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81610" y="6210300"/>
            <a:ext cx="6438265" cy="1476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. Dynamics of alternative polyadenylation and miRNA evasion in key immune genes. Structural models and expression profiles for (A)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Rboh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C_Os11g33120) targeted by osa-miR156f-5p, and (B)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NTL5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C_Os08g44820) targeted by osa-miR159b.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4975"/>
            <a:ext cx="6826885" cy="432752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5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